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  <p:sldId id="262" r:id="rId4"/>
    <p:sldId id="265" r:id="rId5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A488322-F2BA-4B5B-9748-0D474271808F}" styleName="中度样式 3 - 强调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74C1A8A3-306A-4EB7-A6B1-4F7E0EB9C5D6}" styleName="中度样式 3 - 强调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357" autoAdjust="0"/>
  </p:normalViewPr>
  <p:slideViewPr>
    <p:cSldViewPr snapToGrid="0">
      <p:cViewPr varScale="1">
        <p:scale>
          <a:sx n="63" d="100"/>
          <a:sy n="63" d="100"/>
        </p:scale>
        <p:origin x="2294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78F2-D191-4671-B7D4-8D699939EE55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B42A1-8DBF-45EA-ACB4-C3DD7257DFE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78F2-D191-4671-B7D4-8D699939EE55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B42A1-8DBF-45EA-ACB4-C3DD7257DFE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78F2-D191-4671-B7D4-8D699939EE55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B42A1-8DBF-45EA-ACB4-C3DD7257DFE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78F2-D191-4671-B7D4-8D699939EE55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B42A1-8DBF-45EA-ACB4-C3DD7257DFE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78F2-D191-4671-B7D4-8D699939EE55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B42A1-8DBF-45EA-ACB4-C3DD7257DFE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78F2-D191-4671-B7D4-8D699939EE55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B42A1-8DBF-45EA-ACB4-C3DD7257DFE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78F2-D191-4671-B7D4-8D699939EE55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B42A1-8DBF-45EA-ACB4-C3DD7257DFE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78F2-D191-4671-B7D4-8D699939EE55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B42A1-8DBF-45EA-ACB4-C3DD7257DFE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78F2-D191-4671-B7D4-8D699939EE55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B42A1-8DBF-45EA-ACB4-C3DD7257DFE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78F2-D191-4671-B7D4-8D699939EE55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B42A1-8DBF-45EA-ACB4-C3DD7257DFE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78F2-D191-4671-B7D4-8D699939EE55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B42A1-8DBF-45EA-ACB4-C3DD7257DFE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9D78F2-D191-4671-B7D4-8D699939EE55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B42A1-8DBF-45EA-ACB4-C3DD7257DFE0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1132642" y="543788"/>
          <a:ext cx="5191958" cy="2270723"/>
        </p:xfrm>
        <a:graphic>
          <a:graphicData uri="http://schemas.openxmlformats.org/drawingml/2006/table">
            <a:tbl>
              <a:tblPr/>
              <a:tblGrid>
                <a:gridCol w="538841"/>
                <a:gridCol w="1170295"/>
                <a:gridCol w="1942073"/>
                <a:gridCol w="1540749"/>
              </a:tblGrid>
              <a:tr h="4313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im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lant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mber of Citrus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hiteflies attracte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tio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29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 hpi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althy 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.0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229919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VCV-infecte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.0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229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 hpi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althy 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.0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229919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VCV-infecte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5.0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229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2 hpi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althy contro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.4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229919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VCV-infecte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0.6%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229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6 hpi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althy 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.3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229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VCV-infecte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5.7%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963" marR="8963" marT="8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975360" y="9162415"/>
            <a:ext cx="6050280" cy="4387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30" dirty="0">
                <a:latin typeface="Arial" panose="020B0604020202020204" pitchFamily="34" charset="0"/>
                <a:cs typeface="Arial" panose="020B0604020202020204" pitchFamily="34" charset="0"/>
              </a:rPr>
              <a:t>Table S1. Timelapse calculation of citrus whitefly population attracted by CYVCV-infected Eureka lemon and the control plants in free-choice bioassays.</a:t>
            </a:r>
            <a:endParaRPr lang="en-US" sz="113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Table 1"/>
          <p:cNvGraphicFramePr/>
          <p:nvPr/>
        </p:nvGraphicFramePr>
        <p:xfrm>
          <a:off x="1132840" y="3307715"/>
          <a:ext cx="5278120" cy="2477770"/>
        </p:xfrm>
        <a:graphic>
          <a:graphicData uri="http://schemas.openxmlformats.org/drawingml/2006/table">
            <a:tbl>
              <a:tblPr/>
              <a:tblGrid>
                <a:gridCol w="609600"/>
                <a:gridCol w="1346200"/>
                <a:gridCol w="1560830"/>
                <a:gridCol w="1761490"/>
              </a:tblGrid>
              <a:tr h="435610">
                <a:tc>
                  <a:txBody>
                    <a:bodyPr/>
                    <a:p>
                      <a:pPr algn="ctr" fontAlgn="b">
                        <a:buClrTx/>
                        <a:buSzTx/>
                        <a:buFontTx/>
                      </a:pPr>
                      <a:r>
                        <a:rPr lang="en-US" sz="11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ime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37" marR="7937" marT="7937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>
                        <a:buClrTx/>
                        <a:buSzTx/>
                        <a:buFontTx/>
                      </a:pPr>
                      <a:r>
                        <a:rPr lang="en-US" sz="11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lants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37" marR="7937" marT="7937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>
                        <a:buClrTx/>
                        <a:buSzTx/>
                        <a:buFontTx/>
                      </a:pPr>
                      <a:r>
                        <a:rPr lang="en-US" sz="11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mber of Citrus whiteflies attracted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37" marR="7937" marT="7937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>
                        <a:buClrTx/>
                        <a:buSzTx/>
                        <a:buFontTx/>
                      </a:pPr>
                      <a:r>
                        <a:rPr lang="en-US" sz="11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tio </a:t>
                      </a:r>
                      <a:endParaRPr lang="en-US" sz="1100" b="0" i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37" marR="7937" marT="7937" marB="0" anchor="ctr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98120"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24 hpi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Healthy control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33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54.10%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89560">
                <a:tc>
                  <a:txBody>
                    <a:bodyPr/>
                    <a:p>
                      <a:pPr algn="ctr" fontAlgn="ctr"/>
                      <a:r>
                        <a:rPr sz="1800" b="0" i="0">
                          <a:solidFill>
                            <a:sysClr val="windowText" lastClr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 </a:t>
                      </a:r>
                      <a:endParaRPr sz="1800" b="0" i="0">
                        <a:solidFill>
                          <a:sysClr val="windowText" lastClr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CYVCV-infected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28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45.90%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120"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48 hpi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Healthy control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16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43.20%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89560">
                <a:tc>
                  <a:txBody>
                    <a:bodyPr/>
                    <a:p>
                      <a:pPr algn="ctr" fontAlgn="ctr"/>
                      <a:r>
                        <a:rPr sz="1800" b="0" i="0">
                          <a:solidFill>
                            <a:sysClr val="windowText" lastClr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 </a:t>
                      </a:r>
                      <a:endParaRPr sz="1800" b="0" i="0">
                        <a:solidFill>
                          <a:sysClr val="windowText" lastClr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CYVCV-infected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21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56.80%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120"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72 hpi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Healthy control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0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0%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89560">
                <a:tc>
                  <a:txBody>
                    <a:bodyPr/>
                    <a:p>
                      <a:pPr algn="ctr" fontAlgn="ctr"/>
                      <a:r>
                        <a:rPr sz="1800" b="0" i="0">
                          <a:solidFill>
                            <a:sysClr val="windowText" lastClr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 </a:t>
                      </a:r>
                      <a:endParaRPr sz="1800" b="0" i="0">
                        <a:solidFill>
                          <a:sysClr val="windowText" lastClr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CYVCV-infected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13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100%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89560"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96 hpi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Healthy control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0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sz="1800" b="0" i="0">
                          <a:solidFill>
                            <a:sysClr val="windowText" lastClr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 </a:t>
                      </a:r>
                      <a:endParaRPr sz="1800" b="0" i="0">
                        <a:solidFill>
                          <a:sysClr val="windowText" lastClr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89560"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 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CYVCV-infected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0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ctr"/>
                      <a:r>
                        <a:rPr sz="1800" b="0" i="0">
                          <a:solidFill>
                            <a:sysClr val="windowText" lastClr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 </a:t>
                      </a:r>
                      <a:endParaRPr sz="1800" b="0" i="0">
                        <a:solidFill>
                          <a:sysClr val="windowText" lastClr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7" name="Content Placeholder 6"/>
          <p:cNvGraphicFramePr/>
          <p:nvPr>
            <p:ph idx="1"/>
          </p:nvPr>
        </p:nvGraphicFramePr>
        <p:xfrm>
          <a:off x="1062038" y="6380904"/>
          <a:ext cx="5372100" cy="2526665"/>
        </p:xfrm>
        <a:graphic>
          <a:graphicData uri="http://schemas.openxmlformats.org/drawingml/2006/table">
            <a:tbl>
              <a:tblPr/>
              <a:tblGrid>
                <a:gridCol w="676275"/>
                <a:gridCol w="1407160"/>
                <a:gridCol w="1692275"/>
                <a:gridCol w="1596390"/>
              </a:tblGrid>
              <a:tr h="484505"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Time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Plants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Number of Citrus whiteflies attracted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Ratio</a:t>
                      </a:r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 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98120"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24 hpi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Healthy control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38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47.50%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89560">
                <a:tc>
                  <a:txBody>
                    <a:bodyPr/>
                    <a:p>
                      <a:pPr algn="ctr" fontAlgn="ctr"/>
                      <a:r>
                        <a:rPr sz="1800" b="0" i="0">
                          <a:solidFill>
                            <a:sysClr val="windowText" lastClr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 </a:t>
                      </a:r>
                      <a:endParaRPr sz="1800" b="0" i="0">
                        <a:solidFill>
                          <a:sysClr val="windowText" lastClr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CYVCV-infected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42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52.50%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120"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48 hpi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Healthy control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5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12.80%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89560">
                <a:tc>
                  <a:txBody>
                    <a:bodyPr/>
                    <a:p>
                      <a:pPr algn="ctr" fontAlgn="ctr"/>
                      <a:r>
                        <a:rPr sz="1800" b="0" i="0">
                          <a:solidFill>
                            <a:sysClr val="windowText" lastClr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 </a:t>
                      </a:r>
                      <a:endParaRPr sz="1800" b="0" i="0">
                        <a:solidFill>
                          <a:sysClr val="windowText" lastClr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CYVCV-infected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34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87.20%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8120"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72 hpi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Healthy control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3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10.30%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89560">
                <a:tc>
                  <a:txBody>
                    <a:bodyPr/>
                    <a:p>
                      <a:pPr algn="ctr" fontAlgn="ctr"/>
                      <a:r>
                        <a:rPr sz="1800" b="0" i="0">
                          <a:solidFill>
                            <a:sysClr val="windowText" lastClr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 </a:t>
                      </a:r>
                      <a:endParaRPr sz="1800" b="0" i="0">
                        <a:solidFill>
                          <a:sysClr val="windowText" lastClr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CYVCV-infected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26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89.70%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89560"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96 hpi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Healthy control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1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4%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89560"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 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CYVCV-infected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24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p>
                      <a:pPr algn="ctr" fontAlgn="b"/>
                      <a:r>
                        <a:rPr sz="1100" b="0" i="0">
                          <a:solidFill>
                            <a:srgbClr val="000000"/>
                          </a:solidFill>
                          <a:latin typeface="Arial" panose="020B0604020202020204"/>
                          <a:ea typeface="Arial" panose="020B0604020202020204"/>
                        </a:rPr>
                        <a:t>96%</a:t>
                      </a:r>
                      <a:endParaRPr sz="1100" b="0" i="0">
                        <a:solidFill>
                          <a:srgbClr val="000000"/>
                        </a:solidFill>
                        <a:latin typeface="Arial" panose="020B0604020202020204"/>
                        <a:ea typeface="Arial" panose="020B0604020202020204"/>
                      </a:endParaRPr>
                    </a:p>
                  </a:txBody>
                  <a:tcPr marL="7937" marR="7937" marT="7937" marB="0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9" name="Text Box 8"/>
          <p:cNvSpPr txBox="1"/>
          <p:nvPr/>
        </p:nvSpPr>
        <p:spPr>
          <a:xfrm>
            <a:off x="689610" y="267970"/>
            <a:ext cx="25908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>
                <a:latin typeface="Times New Roman" panose="02020603050405020304" charset="0"/>
                <a:cs typeface="Times New Roman" panose="02020603050405020304" charset="0"/>
              </a:rPr>
              <a:t>Biological replicate 1</a:t>
            </a:r>
            <a:endParaRPr lang="en-US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" name="Text Box 9"/>
          <p:cNvSpPr txBox="1"/>
          <p:nvPr/>
        </p:nvSpPr>
        <p:spPr>
          <a:xfrm>
            <a:off x="689610" y="3032125"/>
            <a:ext cx="25908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>
                <a:latin typeface="Times New Roman" panose="02020603050405020304" charset="0"/>
                <a:cs typeface="Times New Roman" panose="02020603050405020304" charset="0"/>
              </a:rPr>
              <a:t>Biological replicate 2</a:t>
            </a:r>
            <a:endParaRPr lang="en-US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1" name="Text Box 10"/>
          <p:cNvSpPr txBox="1"/>
          <p:nvPr/>
        </p:nvSpPr>
        <p:spPr>
          <a:xfrm>
            <a:off x="836930" y="6105525"/>
            <a:ext cx="17310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1200">
                <a:latin typeface="Times New Roman" panose="02020603050405020304" charset="0"/>
                <a:cs typeface="Times New Roman" panose="02020603050405020304" charset="0"/>
              </a:rPr>
              <a:t>Biological replicate 3</a:t>
            </a:r>
            <a:endParaRPr lang="en-US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520700" y="1001486"/>
          <a:ext cx="6242050" cy="1622269"/>
        </p:xfrm>
        <a:graphic>
          <a:graphicData uri="http://schemas.openxmlformats.org/drawingml/2006/table">
            <a:tbl>
              <a:tblPr>
                <a:tableStyleId>{2A488322-F2BA-4B5B-9748-0D474271808F}</a:tableStyleId>
              </a:tblPr>
              <a:tblGrid>
                <a:gridCol w="1835150"/>
                <a:gridCol w="1739900"/>
                <a:gridCol w="1206500"/>
                <a:gridCol w="1460500"/>
              </a:tblGrid>
              <a:tr h="6939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and ratio of citrus whiteflies attracted by CYVCV-infected E. lem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and ratio of citrus whiteflies attracted by healthy contro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responsive </a:t>
                      </a:r>
                      <a:endParaRPr lang="en-US" sz="120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trus whitefli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otal number of white flies tested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94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30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5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55%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3094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40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5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45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3094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37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1.1%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(51.9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20700" y="2758724"/>
            <a:ext cx="6242050" cy="4387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30" dirty="0">
                <a:latin typeface="Arial" panose="020B0604020202020204" pitchFamily="34" charset="0"/>
                <a:cs typeface="Arial" panose="020B0604020202020204" pitchFamily="34" charset="0"/>
              </a:rPr>
              <a:t>Table S2. Statistical calculation of citrus whiteflies attracted by Citrus yellow vein clearing virus (CYVCV)-infected Eureka lemon and the healthy control plants in Y-tube olfactometry assays. </a:t>
            </a:r>
            <a:endParaRPr lang="en-US" sz="113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/>
          <p:cNvGraphicFramePr>
            <a:graphicFrameLocks noGrp="1"/>
          </p:cNvGraphicFramePr>
          <p:nvPr/>
        </p:nvGraphicFramePr>
        <p:xfrm>
          <a:off x="940248" y="488950"/>
          <a:ext cx="5891904" cy="2306320"/>
        </p:xfrm>
        <a:graphic>
          <a:graphicData uri="http://schemas.openxmlformats.org/drawingml/2006/table">
            <a:tbl>
              <a:tblPr>
                <a:tableStyleId>{74C1A8A3-306A-4EB7-A6B1-4F7E0EB9C5D6}</a:tableStyleId>
              </a:tblPr>
              <a:tblGrid>
                <a:gridCol w="1472976"/>
                <a:gridCol w="1472976"/>
                <a:gridCol w="1472976"/>
                <a:gridCol w="1472976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and ratio of alates attracted by CYVCV-infected E. lem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and ratio of alates attracted by Healthy E. lem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responsive alates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otal number of alates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21.88%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 (37.5%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40.63%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20%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30%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(50%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42.3%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34.6%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23.1%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17.1%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25.7%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(57.1%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765175" y="2958749"/>
            <a:ext cx="6242050" cy="6121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30" dirty="0">
                <a:latin typeface="Arial" panose="020B0604020202020204" pitchFamily="34" charset="0"/>
                <a:cs typeface="Arial" panose="020B0604020202020204" pitchFamily="34" charset="0"/>
              </a:rPr>
              <a:t>Table S3. Statistical calculation of spirea aphid alates attracted by Citrus yellow vein clearing virus (CYVCV)-infected Eureka lemon and the healthy control plants in Y-tube olfactometry assays. </a:t>
            </a:r>
            <a:endParaRPr lang="en-US" sz="113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1913</Words>
  <Application>WPS Presentation</Application>
  <PresentationFormat>Custom</PresentationFormat>
  <Paragraphs>296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3" baseType="lpstr">
      <vt:lpstr>Arial</vt:lpstr>
      <vt:lpstr>SimSun</vt:lpstr>
      <vt:lpstr>Wingdings</vt:lpstr>
      <vt:lpstr>Arial</vt:lpstr>
      <vt:lpstr>Times New Roman</vt:lpstr>
      <vt:lpstr>Microsoft YaHei</vt:lpstr>
      <vt:lpstr>Arial Unicode MS</vt:lpstr>
      <vt:lpstr>Calibri Light</vt:lpstr>
      <vt:lpstr>Calibri</vt:lpstr>
      <vt:lpstr>Office Theme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, Yongduo - ARS</dc:creator>
  <cp:lastModifiedBy>Yongduo Sun</cp:lastModifiedBy>
  <cp:revision>60</cp:revision>
  <dcterms:created xsi:type="dcterms:W3CDTF">2024-04-29T21:19:00Z</dcterms:created>
  <dcterms:modified xsi:type="dcterms:W3CDTF">2025-01-08T22:14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8CBC53325FD4150BC07F4CF9656DA4F_12</vt:lpwstr>
  </property>
  <property fmtid="{D5CDD505-2E9C-101B-9397-08002B2CF9AE}" pid="3" name="KSOProductBuildVer">
    <vt:lpwstr>1033-12.2.0.19307</vt:lpwstr>
  </property>
</Properties>
</file>